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2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7986F3-5DCB-4067-89CE-34F0198E485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E3B7C5-F096-4886-B2EF-7CEB17E80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453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E9FAB2-DE7F-4DD4-AC61-AE6E0F66EF0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5486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550E9-9E84-46DD-A1DF-2099C425872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BE691-0C8C-4BFB-8A4A-09FA69C59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878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550E9-9E84-46DD-A1DF-2099C425872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BE691-0C8C-4BFB-8A4A-09FA69C59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334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550E9-9E84-46DD-A1DF-2099C425872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BE691-0C8C-4BFB-8A4A-09FA69C59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1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550E9-9E84-46DD-A1DF-2099C425872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BE691-0C8C-4BFB-8A4A-09FA69C59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305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550E9-9E84-46DD-A1DF-2099C425872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BE691-0C8C-4BFB-8A4A-09FA69C59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013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550E9-9E84-46DD-A1DF-2099C425872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BE691-0C8C-4BFB-8A4A-09FA69C59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00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550E9-9E84-46DD-A1DF-2099C425872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BE691-0C8C-4BFB-8A4A-09FA69C59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709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550E9-9E84-46DD-A1DF-2099C425872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BE691-0C8C-4BFB-8A4A-09FA69C59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057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550E9-9E84-46DD-A1DF-2099C425872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BE691-0C8C-4BFB-8A4A-09FA69C59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714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550E9-9E84-46DD-A1DF-2099C425872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BE691-0C8C-4BFB-8A4A-09FA69C59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769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550E9-9E84-46DD-A1DF-2099C425872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BE691-0C8C-4BFB-8A4A-09FA69C59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016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550E9-9E84-46DD-A1DF-2099C4258727}" type="datetimeFigureOut">
              <a:rPr lang="en-US" smtClean="0"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1BE691-0C8C-4BFB-8A4A-09FA69C59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09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Description: http://hgserver1.amc.nl/r2/graph/--Boxplot-13976060319653.png"/>
          <p:cNvPicPr>
            <a:picLocks noChangeAspect="1" noChangeArrowheads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77" t="8292" b="31076"/>
          <a:stretch/>
        </p:blipFill>
        <p:spPr bwMode="auto">
          <a:xfrm>
            <a:off x="5014762" y="1676401"/>
            <a:ext cx="3637014" cy="28442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Description: http://hgserver1.amc.nl/r2/graph/--Boxplot-13976060927371.png"/>
          <p:cNvPicPr>
            <a:picLocks noChangeAspect="1" noChangeArrowheads="1"/>
          </p:cNvPicPr>
          <p:nvPr/>
        </p:nvPicPr>
        <p:blipFill rotWithShape="1"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73" t="8567" b="30815"/>
          <a:stretch/>
        </p:blipFill>
        <p:spPr bwMode="auto">
          <a:xfrm>
            <a:off x="577516" y="1524000"/>
            <a:ext cx="3753703" cy="29806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29111" y="149173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495800" y="149173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-755363" y="2773751"/>
            <a:ext cx="24717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GGT1 mRNA express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49267" y="4520665"/>
            <a:ext cx="10086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rmal Bra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824214" y="4491311"/>
            <a:ext cx="1029449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mmortalized </a:t>
            </a:r>
          </a:p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BM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ll sampl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990476" y="4488905"/>
            <a:ext cx="102944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rimary GBM</a:t>
            </a:r>
          </a:p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287543" y="4527560"/>
            <a:ext cx="10086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rmal Bra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262490" y="4498206"/>
            <a:ext cx="1029449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mmortalized </a:t>
            </a:r>
          </a:p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BM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ll sampl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391400" y="4495800"/>
            <a:ext cx="102944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rimary GBM</a:t>
            </a:r>
          </a:p>
          <a:p>
            <a:pPr algn="ctr"/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3574138" y="2958418"/>
            <a:ext cx="24717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GGT5 mRNA express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52400" y="6336268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7011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32</Words>
  <Application>Microsoft Office PowerPoint</Application>
  <PresentationFormat>On-screen Show (4:3)</PresentationFormat>
  <Paragraphs>1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rdon Lab</dc:creator>
  <cp:lastModifiedBy>Gordon Lab</cp:lastModifiedBy>
  <cp:revision>8</cp:revision>
  <dcterms:created xsi:type="dcterms:W3CDTF">2014-07-17T17:39:55Z</dcterms:created>
  <dcterms:modified xsi:type="dcterms:W3CDTF">2015-02-23T19:03:57Z</dcterms:modified>
</cp:coreProperties>
</file>